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3716000" cy="9144000"/>
  <p:notesSz cx="6858000" cy="9144000"/>
  <p:defaultTextStyle>
    <a:defPPr>
      <a:defRPr lang="en-US"/>
    </a:defPPr>
    <a:lvl1pPr marL="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66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109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3\Desktop\Thermal%20time%20-LS%20scan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CHICKPEA-LEASYSCAN%20QTL%20ANALYSIS\ANALYSIS\plant_height-RIL1882-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solidFill>
                  <a:srgbClr val="0000FF"/>
                </a:solidFill>
              </a:defRPr>
            </a:pPr>
            <a:r>
              <a:rPr lang="en-US">
                <a:solidFill>
                  <a:srgbClr val="0000FF"/>
                </a:solidFill>
              </a:rPr>
              <a:t>3D-Leaf area -Parental lines</a:t>
            </a:r>
          </a:p>
        </c:rich>
      </c:tx>
      <c:layout>
        <c:manualLayout>
          <c:xMode val="edge"/>
          <c:yMode val="edge"/>
          <c:x val="0.31268913754201777"/>
          <c:y val="2.429321334833145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405607869405033"/>
          <c:y val="2.5225596800399951E-2"/>
          <c:w val="0.8860914377434419"/>
          <c:h val="0.74750172627476075"/>
        </c:manualLayout>
      </c:layout>
      <c:lineChart>
        <c:grouping val="standard"/>
        <c:varyColors val="0"/>
        <c:ser>
          <c:idx val="1"/>
          <c:order val="0"/>
          <c:tx>
            <c:v>ICC 4958-High vigour parent</c:v>
          </c:tx>
          <c:spPr>
            <a:ln w="28575">
              <a:solidFill>
                <a:srgbClr val="0000FF"/>
              </a:solidFill>
            </a:ln>
          </c:spPr>
          <c:marker>
            <c:symbol val="circle"/>
            <c:size val="8"/>
            <c:spPr>
              <a:solidFill>
                <a:srgbClr val="66FF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M$17:$AR$17</c:f>
                <c:numCache>
                  <c:formatCode>General</c:formatCode>
                  <c:ptCount val="32"/>
                  <c:pt idx="0">
                    <c:v>622.809449674441</c:v>
                  </c:pt>
                  <c:pt idx="1">
                    <c:v>569.83619699568089</c:v>
                  </c:pt>
                  <c:pt idx="2">
                    <c:v>530.78948536851942</c:v>
                  </c:pt>
                  <c:pt idx="3">
                    <c:v>963.00798455077302</c:v>
                  </c:pt>
                  <c:pt idx="4">
                    <c:v>1097.4218735927557</c:v>
                  </c:pt>
                  <c:pt idx="5">
                    <c:v>889.53068171642644</c:v>
                  </c:pt>
                  <c:pt idx="6">
                    <c:v>983.11244725848826</c:v>
                  </c:pt>
                  <c:pt idx="7">
                    <c:v>912.93946150718079</c:v>
                  </c:pt>
                  <c:pt idx="8">
                    <c:v>762.87141076822286</c:v>
                  </c:pt>
                  <c:pt idx="9">
                    <c:v>1367.2872744270417</c:v>
                  </c:pt>
                  <c:pt idx="10">
                    <c:v>1543.0648508946949</c:v>
                  </c:pt>
                  <c:pt idx="11">
                    <c:v>1987.5323723755391</c:v>
                  </c:pt>
                  <c:pt idx="12">
                    <c:v>2442.3783179109168</c:v>
                  </c:pt>
                  <c:pt idx="13">
                    <c:v>2207.9798796542118</c:v>
                  </c:pt>
                  <c:pt idx="14">
                    <c:v>1672.6358661063043</c:v>
                  </c:pt>
                  <c:pt idx="15">
                    <c:v>2333.2783521515812</c:v>
                  </c:pt>
                  <c:pt idx="16">
                    <c:v>2684.2447094351974</c:v>
                  </c:pt>
                  <c:pt idx="17">
                    <c:v>3229.4377546083497</c:v>
                  </c:pt>
                  <c:pt idx="18">
                    <c:v>3109.6563022347032</c:v>
                  </c:pt>
                  <c:pt idx="19">
                    <c:v>2870.162896005404</c:v>
                  </c:pt>
                  <c:pt idx="20">
                    <c:v>2658.1466408229849</c:v>
                  </c:pt>
                  <c:pt idx="21">
                    <c:v>1136.8594602353137</c:v>
                  </c:pt>
                  <c:pt idx="22">
                    <c:v>2149.1539061083422</c:v>
                  </c:pt>
                  <c:pt idx="23">
                    <c:v>2067.8178273152998</c:v>
                  </c:pt>
                  <c:pt idx="24">
                    <c:v>1898.1367371031877</c:v>
                  </c:pt>
                  <c:pt idx="25">
                    <c:v>1336.6350387972875</c:v>
                  </c:pt>
                  <c:pt idx="26">
                    <c:v>915.98405004514939</c:v>
                  </c:pt>
                  <c:pt idx="27">
                    <c:v>781.17723071754938</c:v>
                  </c:pt>
                  <c:pt idx="28">
                    <c:v>2595.2223469871983</c:v>
                  </c:pt>
                  <c:pt idx="29">
                    <c:v>3207.1201987427389</c:v>
                  </c:pt>
                  <c:pt idx="30">
                    <c:v>3000.7210315178918</c:v>
                  </c:pt>
                  <c:pt idx="31">
                    <c:v>2875.4935463942716</c:v>
                  </c:pt>
                </c:numCache>
              </c:numRef>
            </c:plus>
            <c:minus>
              <c:numRef>
                <c:f>Sheet3!$M$17:$AR$17</c:f>
                <c:numCache>
                  <c:formatCode>General</c:formatCode>
                  <c:ptCount val="32"/>
                  <c:pt idx="0">
                    <c:v>622.809449674441</c:v>
                  </c:pt>
                  <c:pt idx="1">
                    <c:v>569.83619699568089</c:v>
                  </c:pt>
                  <c:pt idx="2">
                    <c:v>530.78948536851942</c:v>
                  </c:pt>
                  <c:pt idx="3">
                    <c:v>963.00798455077302</c:v>
                  </c:pt>
                  <c:pt idx="4">
                    <c:v>1097.4218735927557</c:v>
                  </c:pt>
                  <c:pt idx="5">
                    <c:v>889.53068171642644</c:v>
                  </c:pt>
                  <c:pt idx="6">
                    <c:v>983.11244725848826</c:v>
                  </c:pt>
                  <c:pt idx="7">
                    <c:v>912.93946150718079</c:v>
                  </c:pt>
                  <c:pt idx="8">
                    <c:v>762.87141076822286</c:v>
                  </c:pt>
                  <c:pt idx="9">
                    <c:v>1367.2872744270417</c:v>
                  </c:pt>
                  <c:pt idx="10">
                    <c:v>1543.0648508946949</c:v>
                  </c:pt>
                  <c:pt idx="11">
                    <c:v>1987.5323723755391</c:v>
                  </c:pt>
                  <c:pt idx="12">
                    <c:v>2442.3783179109168</c:v>
                  </c:pt>
                  <c:pt idx="13">
                    <c:v>2207.9798796542118</c:v>
                  </c:pt>
                  <c:pt idx="14">
                    <c:v>1672.6358661063043</c:v>
                  </c:pt>
                  <c:pt idx="15">
                    <c:v>2333.2783521515812</c:v>
                  </c:pt>
                  <c:pt idx="16">
                    <c:v>2684.2447094351974</c:v>
                  </c:pt>
                  <c:pt idx="17">
                    <c:v>3229.4377546083497</c:v>
                  </c:pt>
                  <c:pt idx="18">
                    <c:v>3109.6563022347032</c:v>
                  </c:pt>
                  <c:pt idx="19">
                    <c:v>2870.162896005404</c:v>
                  </c:pt>
                  <c:pt idx="20">
                    <c:v>2658.1466408229849</c:v>
                  </c:pt>
                  <c:pt idx="21">
                    <c:v>1136.8594602353137</c:v>
                  </c:pt>
                  <c:pt idx="22">
                    <c:v>2149.1539061083422</c:v>
                  </c:pt>
                  <c:pt idx="23">
                    <c:v>2067.8178273152998</c:v>
                  </c:pt>
                  <c:pt idx="24">
                    <c:v>1898.1367371031877</c:v>
                  </c:pt>
                  <c:pt idx="25">
                    <c:v>1336.6350387972875</c:v>
                  </c:pt>
                  <c:pt idx="26">
                    <c:v>915.98405004514939</c:v>
                  </c:pt>
                  <c:pt idx="27">
                    <c:v>781.17723071754938</c:v>
                  </c:pt>
                  <c:pt idx="28">
                    <c:v>2595.2223469871983</c:v>
                  </c:pt>
                  <c:pt idx="29">
                    <c:v>3207.1201987427389</c:v>
                  </c:pt>
                  <c:pt idx="30">
                    <c:v>3000.7210315178918</c:v>
                  </c:pt>
                  <c:pt idx="31">
                    <c:v>2875.4935463942716</c:v>
                  </c:pt>
                </c:numCache>
              </c:numRef>
            </c:minus>
            <c:spPr>
              <a:ln w="15875"/>
            </c:spPr>
          </c:errBars>
          <c:cat>
            <c:numRef>
              <c:f>Sheet3!$M$14:$AR$14</c:f>
              <c:numCache>
                <c:formatCode>General</c:formatCode>
                <c:ptCount val="32"/>
                <c:pt idx="0">
                  <c:v>228</c:v>
                </c:pt>
                <c:pt idx="1">
                  <c:v>247</c:v>
                </c:pt>
                <c:pt idx="2">
                  <c:v>266</c:v>
                </c:pt>
                <c:pt idx="3">
                  <c:v>285</c:v>
                </c:pt>
                <c:pt idx="4">
                  <c:v>304</c:v>
                </c:pt>
                <c:pt idx="5">
                  <c:v>323</c:v>
                </c:pt>
                <c:pt idx="6">
                  <c:v>342</c:v>
                </c:pt>
                <c:pt idx="7">
                  <c:v>361</c:v>
                </c:pt>
                <c:pt idx="8">
                  <c:v>380</c:v>
                </c:pt>
                <c:pt idx="9">
                  <c:v>399</c:v>
                </c:pt>
                <c:pt idx="10">
                  <c:v>418</c:v>
                </c:pt>
                <c:pt idx="11">
                  <c:v>437</c:v>
                </c:pt>
                <c:pt idx="12">
                  <c:v>456</c:v>
                </c:pt>
                <c:pt idx="13">
                  <c:v>475</c:v>
                </c:pt>
                <c:pt idx="14">
                  <c:v>494</c:v>
                </c:pt>
                <c:pt idx="15">
                  <c:v>513</c:v>
                </c:pt>
                <c:pt idx="16">
                  <c:v>532</c:v>
                </c:pt>
                <c:pt idx="17">
                  <c:v>551</c:v>
                </c:pt>
                <c:pt idx="18">
                  <c:v>570</c:v>
                </c:pt>
                <c:pt idx="19">
                  <c:v>589</c:v>
                </c:pt>
                <c:pt idx="20" formatCode="0">
                  <c:v>608</c:v>
                </c:pt>
                <c:pt idx="21" formatCode="0">
                  <c:v>627</c:v>
                </c:pt>
                <c:pt idx="22" formatCode="0">
                  <c:v>646</c:v>
                </c:pt>
                <c:pt idx="23" formatCode="0">
                  <c:v>665</c:v>
                </c:pt>
                <c:pt idx="24" formatCode="0">
                  <c:v>680</c:v>
                </c:pt>
                <c:pt idx="25" formatCode="0">
                  <c:v>696.05</c:v>
                </c:pt>
                <c:pt idx="26" formatCode="0">
                  <c:v>712.55</c:v>
                </c:pt>
                <c:pt idx="27" formatCode="0">
                  <c:v>730.34999999999991</c:v>
                </c:pt>
                <c:pt idx="28" formatCode="0">
                  <c:v>749.05</c:v>
                </c:pt>
                <c:pt idx="29" formatCode="0">
                  <c:v>768.05</c:v>
                </c:pt>
                <c:pt idx="30" formatCode="0">
                  <c:v>787.05</c:v>
                </c:pt>
                <c:pt idx="31" formatCode="0">
                  <c:v>806.05</c:v>
                </c:pt>
              </c:numCache>
            </c:numRef>
          </c:cat>
          <c:val>
            <c:numRef>
              <c:f>Sheet3!$M$15:$AR$15</c:f>
              <c:numCache>
                <c:formatCode>0</c:formatCode>
                <c:ptCount val="32"/>
                <c:pt idx="0">
                  <c:v>39243.332380952379</c:v>
                </c:pt>
                <c:pt idx="1">
                  <c:v>41335.710476190485</c:v>
                </c:pt>
                <c:pt idx="2">
                  <c:v>42120.433333333334</c:v>
                </c:pt>
                <c:pt idx="3">
                  <c:v>43745.509047619045</c:v>
                </c:pt>
                <c:pt idx="4">
                  <c:v>43920.896190476189</c:v>
                </c:pt>
                <c:pt idx="5">
                  <c:v>46188.839047619047</c:v>
                </c:pt>
                <c:pt idx="6">
                  <c:v>43487.142380952377</c:v>
                </c:pt>
                <c:pt idx="7">
                  <c:v>47397.365238095234</c:v>
                </c:pt>
                <c:pt idx="8">
                  <c:v>47989.203095238096</c:v>
                </c:pt>
                <c:pt idx="9">
                  <c:v>53760.622380952387</c:v>
                </c:pt>
                <c:pt idx="10">
                  <c:v>52116.49</c:v>
                </c:pt>
                <c:pt idx="11">
                  <c:v>53218.71</c:v>
                </c:pt>
                <c:pt idx="12">
                  <c:v>55933.51142857143</c:v>
                </c:pt>
                <c:pt idx="13">
                  <c:v>58903.65285714285</c:v>
                </c:pt>
                <c:pt idx="14">
                  <c:v>57218.876666666671</c:v>
                </c:pt>
                <c:pt idx="15">
                  <c:v>59422.066190476187</c:v>
                </c:pt>
                <c:pt idx="16">
                  <c:v>63375.49380952381</c:v>
                </c:pt>
                <c:pt idx="17">
                  <c:v>64829.934761904762</c:v>
                </c:pt>
                <c:pt idx="18">
                  <c:v>68078.684761904748</c:v>
                </c:pt>
                <c:pt idx="19">
                  <c:v>73972.208571428579</c:v>
                </c:pt>
                <c:pt idx="20">
                  <c:v>76528.003333333341</c:v>
                </c:pt>
                <c:pt idx="21">
                  <c:v>75414.885714285731</c:v>
                </c:pt>
                <c:pt idx="22">
                  <c:v>74107.42333333334</c:v>
                </c:pt>
                <c:pt idx="23">
                  <c:v>75390.083333333328</c:v>
                </c:pt>
                <c:pt idx="24">
                  <c:v>77745.433333333334</c:v>
                </c:pt>
                <c:pt idx="25">
                  <c:v>79054.261190476202</c:v>
                </c:pt>
                <c:pt idx="26">
                  <c:v>80363.08904761904</c:v>
                </c:pt>
                <c:pt idx="27">
                  <c:v>83380.59325396824</c:v>
                </c:pt>
                <c:pt idx="28">
                  <c:v>84120.466190476203</c:v>
                </c:pt>
                <c:pt idx="29">
                  <c:v>85008.764285714293</c:v>
                </c:pt>
                <c:pt idx="30">
                  <c:v>88201.256190476182</c:v>
                </c:pt>
                <c:pt idx="31">
                  <c:v>90635.105714285732</c:v>
                </c:pt>
              </c:numCache>
            </c:numRef>
          </c:val>
          <c:smooth val="1"/>
        </c:ser>
        <c:ser>
          <c:idx val="2"/>
          <c:order val="1"/>
          <c:tx>
            <c:v>ICC 1882-Low vigour parent</c:v>
          </c:tx>
          <c:spPr>
            <a:ln w="28575">
              <a:solidFill>
                <a:srgbClr val="FF0000"/>
              </a:solidFill>
            </a:ln>
          </c:spPr>
          <c:marker>
            <c:symbol val="circle"/>
            <c:size val="9"/>
            <c:spPr>
              <a:solidFill>
                <a:srgbClr val="FFFF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M$18:$AR$18</c:f>
                <c:numCache>
                  <c:formatCode>General</c:formatCode>
                  <c:ptCount val="32"/>
                  <c:pt idx="0">
                    <c:v>1439.3704353159847</c:v>
                  </c:pt>
                  <c:pt idx="1">
                    <c:v>1296.3381024263963</c:v>
                  </c:pt>
                  <c:pt idx="2">
                    <c:v>1252.3050207024421</c:v>
                  </c:pt>
                  <c:pt idx="3">
                    <c:v>1557.5006503972013</c:v>
                  </c:pt>
                  <c:pt idx="4">
                    <c:v>2213.9603709497214</c:v>
                  </c:pt>
                  <c:pt idx="5">
                    <c:v>1201.3536552058856</c:v>
                  </c:pt>
                  <c:pt idx="6">
                    <c:v>1104.0507504214534</c:v>
                  </c:pt>
                  <c:pt idx="7">
                    <c:v>1637.9146136678419</c:v>
                  </c:pt>
                  <c:pt idx="8">
                    <c:v>1150.4294318379073</c:v>
                  </c:pt>
                  <c:pt idx="9">
                    <c:v>1482.3559319167884</c:v>
                  </c:pt>
                  <c:pt idx="10">
                    <c:v>951.80376540519364</c:v>
                  </c:pt>
                  <c:pt idx="11">
                    <c:v>1500.425715288419</c:v>
                  </c:pt>
                  <c:pt idx="12">
                    <c:v>1439.4039474341062</c:v>
                  </c:pt>
                  <c:pt idx="13">
                    <c:v>638.3996049149431</c:v>
                  </c:pt>
                  <c:pt idx="14">
                    <c:v>579.38864784090651</c:v>
                  </c:pt>
                  <c:pt idx="15">
                    <c:v>1110.7381832703384</c:v>
                  </c:pt>
                  <c:pt idx="16">
                    <c:v>848.78748205387433</c:v>
                  </c:pt>
                  <c:pt idx="17">
                    <c:v>1086.19629529546</c:v>
                  </c:pt>
                  <c:pt idx="18">
                    <c:v>2426.2099175742815</c:v>
                  </c:pt>
                  <c:pt idx="19">
                    <c:v>157.98324414980652</c:v>
                  </c:pt>
                  <c:pt idx="20">
                    <c:v>1791.6496955785369</c:v>
                  </c:pt>
                  <c:pt idx="21">
                    <c:v>1382.9640642564409</c:v>
                  </c:pt>
                  <c:pt idx="22">
                    <c:v>2154.7664770497245</c:v>
                  </c:pt>
                  <c:pt idx="23">
                    <c:v>55.743405190409746</c:v>
                  </c:pt>
                  <c:pt idx="24">
                    <c:v>1236.1387262083949</c:v>
                  </c:pt>
                  <c:pt idx="25">
                    <c:v>507.72605548941215</c:v>
                  </c:pt>
                  <c:pt idx="26">
                    <c:v>1166.1037996965219</c:v>
                  </c:pt>
                  <c:pt idx="27">
                    <c:v>195.05068999279788</c:v>
                  </c:pt>
                  <c:pt idx="28">
                    <c:v>740.54893570434729</c:v>
                  </c:pt>
                  <c:pt idx="29">
                    <c:v>895.18991005357452</c:v>
                  </c:pt>
                  <c:pt idx="30">
                    <c:v>1805.9794906926472</c:v>
                  </c:pt>
                  <c:pt idx="31">
                    <c:v>1100.048812048306</c:v>
                  </c:pt>
                </c:numCache>
              </c:numRef>
            </c:plus>
            <c:minus>
              <c:numRef>
                <c:f>Sheet3!$M$18:$AR$18</c:f>
                <c:numCache>
                  <c:formatCode>General</c:formatCode>
                  <c:ptCount val="32"/>
                  <c:pt idx="0">
                    <c:v>1439.3704353159847</c:v>
                  </c:pt>
                  <c:pt idx="1">
                    <c:v>1296.3381024263963</c:v>
                  </c:pt>
                  <c:pt idx="2">
                    <c:v>1252.3050207024421</c:v>
                  </c:pt>
                  <c:pt idx="3">
                    <c:v>1557.5006503972013</c:v>
                  </c:pt>
                  <c:pt idx="4">
                    <c:v>2213.9603709497214</c:v>
                  </c:pt>
                  <c:pt idx="5">
                    <c:v>1201.3536552058856</c:v>
                  </c:pt>
                  <c:pt idx="6">
                    <c:v>1104.0507504214534</c:v>
                  </c:pt>
                  <c:pt idx="7">
                    <c:v>1637.9146136678419</c:v>
                  </c:pt>
                  <c:pt idx="8">
                    <c:v>1150.4294318379073</c:v>
                  </c:pt>
                  <c:pt idx="9">
                    <c:v>1482.3559319167884</c:v>
                  </c:pt>
                  <c:pt idx="10">
                    <c:v>951.80376540519364</c:v>
                  </c:pt>
                  <c:pt idx="11">
                    <c:v>1500.425715288419</c:v>
                  </c:pt>
                  <c:pt idx="12">
                    <c:v>1439.4039474341062</c:v>
                  </c:pt>
                  <c:pt idx="13">
                    <c:v>638.3996049149431</c:v>
                  </c:pt>
                  <c:pt idx="14">
                    <c:v>579.38864784090651</c:v>
                  </c:pt>
                  <c:pt idx="15">
                    <c:v>1110.7381832703384</c:v>
                  </c:pt>
                  <c:pt idx="16">
                    <c:v>848.78748205387433</c:v>
                  </c:pt>
                  <c:pt idx="17">
                    <c:v>1086.19629529546</c:v>
                  </c:pt>
                  <c:pt idx="18">
                    <c:v>2426.2099175742815</c:v>
                  </c:pt>
                  <c:pt idx="19">
                    <c:v>157.98324414980652</c:v>
                  </c:pt>
                  <c:pt idx="20">
                    <c:v>1791.6496955785369</c:v>
                  </c:pt>
                  <c:pt idx="21">
                    <c:v>1382.9640642564409</c:v>
                  </c:pt>
                  <c:pt idx="22">
                    <c:v>2154.7664770497245</c:v>
                  </c:pt>
                  <c:pt idx="23">
                    <c:v>55.743405190409746</c:v>
                  </c:pt>
                  <c:pt idx="24">
                    <c:v>1236.1387262083949</c:v>
                  </c:pt>
                  <c:pt idx="25">
                    <c:v>507.72605548941215</c:v>
                  </c:pt>
                  <c:pt idx="26">
                    <c:v>1166.1037996965219</c:v>
                  </c:pt>
                  <c:pt idx="27">
                    <c:v>195.05068999279788</c:v>
                  </c:pt>
                  <c:pt idx="28">
                    <c:v>740.54893570434729</c:v>
                  </c:pt>
                  <c:pt idx="29">
                    <c:v>895.18991005357452</c:v>
                  </c:pt>
                  <c:pt idx="30">
                    <c:v>1805.9794906926472</c:v>
                  </c:pt>
                  <c:pt idx="31">
                    <c:v>1100.048812048306</c:v>
                  </c:pt>
                </c:numCache>
              </c:numRef>
            </c:minus>
            <c:spPr>
              <a:ln w="15875"/>
            </c:spPr>
          </c:errBars>
          <c:cat>
            <c:numRef>
              <c:f>Sheet3!$M$14:$AR$14</c:f>
              <c:numCache>
                <c:formatCode>General</c:formatCode>
                <c:ptCount val="32"/>
                <c:pt idx="0">
                  <c:v>228</c:v>
                </c:pt>
                <c:pt idx="1">
                  <c:v>247</c:v>
                </c:pt>
                <c:pt idx="2">
                  <c:v>266</c:v>
                </c:pt>
                <c:pt idx="3">
                  <c:v>285</c:v>
                </c:pt>
                <c:pt idx="4">
                  <c:v>304</c:v>
                </c:pt>
                <c:pt idx="5">
                  <c:v>323</c:v>
                </c:pt>
                <c:pt idx="6">
                  <c:v>342</c:v>
                </c:pt>
                <c:pt idx="7">
                  <c:v>361</c:v>
                </c:pt>
                <c:pt idx="8">
                  <c:v>380</c:v>
                </c:pt>
                <c:pt idx="9">
                  <c:v>399</c:v>
                </c:pt>
                <c:pt idx="10">
                  <c:v>418</c:v>
                </c:pt>
                <c:pt idx="11">
                  <c:v>437</c:v>
                </c:pt>
                <c:pt idx="12">
                  <c:v>456</c:v>
                </c:pt>
                <c:pt idx="13">
                  <c:v>475</c:v>
                </c:pt>
                <c:pt idx="14">
                  <c:v>494</c:v>
                </c:pt>
                <c:pt idx="15">
                  <c:v>513</c:v>
                </c:pt>
                <c:pt idx="16">
                  <c:v>532</c:v>
                </c:pt>
                <c:pt idx="17">
                  <c:v>551</c:v>
                </c:pt>
                <c:pt idx="18">
                  <c:v>570</c:v>
                </c:pt>
                <c:pt idx="19">
                  <c:v>589</c:v>
                </c:pt>
                <c:pt idx="20" formatCode="0">
                  <c:v>608</c:v>
                </c:pt>
                <c:pt idx="21" formatCode="0">
                  <c:v>627</c:v>
                </c:pt>
                <c:pt idx="22" formatCode="0">
                  <c:v>646</c:v>
                </c:pt>
                <c:pt idx="23" formatCode="0">
                  <c:v>665</c:v>
                </c:pt>
                <c:pt idx="24" formatCode="0">
                  <c:v>680</c:v>
                </c:pt>
                <c:pt idx="25" formatCode="0">
                  <c:v>696.05</c:v>
                </c:pt>
                <c:pt idx="26" formatCode="0">
                  <c:v>712.55</c:v>
                </c:pt>
                <c:pt idx="27" formatCode="0">
                  <c:v>730.34999999999991</c:v>
                </c:pt>
                <c:pt idx="28" formatCode="0">
                  <c:v>749.05</c:v>
                </c:pt>
                <c:pt idx="29" formatCode="0">
                  <c:v>768.05</c:v>
                </c:pt>
                <c:pt idx="30" formatCode="0">
                  <c:v>787.05</c:v>
                </c:pt>
                <c:pt idx="31" formatCode="0">
                  <c:v>806.05</c:v>
                </c:pt>
              </c:numCache>
            </c:numRef>
          </c:cat>
          <c:val>
            <c:numRef>
              <c:f>Sheet3!$M$16:$AR$16</c:f>
              <c:numCache>
                <c:formatCode>0</c:formatCode>
                <c:ptCount val="32"/>
                <c:pt idx="0">
                  <c:v>25751.311111111114</c:v>
                </c:pt>
                <c:pt idx="1">
                  <c:v>28150.12222222222</c:v>
                </c:pt>
                <c:pt idx="2">
                  <c:v>24213.544444444444</c:v>
                </c:pt>
                <c:pt idx="3">
                  <c:v>25101.255555555552</c:v>
                </c:pt>
                <c:pt idx="4">
                  <c:v>24470.777777777777</c:v>
                </c:pt>
                <c:pt idx="5">
                  <c:v>27576.655555555553</c:v>
                </c:pt>
                <c:pt idx="6">
                  <c:v>27145.788888888888</c:v>
                </c:pt>
                <c:pt idx="7">
                  <c:v>25953.7</c:v>
                </c:pt>
                <c:pt idx="8">
                  <c:v>32073.533333333333</c:v>
                </c:pt>
                <c:pt idx="9">
                  <c:v>35734.033333333333</c:v>
                </c:pt>
                <c:pt idx="10">
                  <c:v>36119.211111111115</c:v>
                </c:pt>
                <c:pt idx="11">
                  <c:v>33738.755555555552</c:v>
                </c:pt>
                <c:pt idx="12">
                  <c:v>39007.366666666669</c:v>
                </c:pt>
                <c:pt idx="13">
                  <c:v>39220.666666666664</c:v>
                </c:pt>
                <c:pt idx="14">
                  <c:v>40437.722222222219</c:v>
                </c:pt>
                <c:pt idx="15">
                  <c:v>45936.077777777777</c:v>
                </c:pt>
                <c:pt idx="16">
                  <c:v>46982.977777777778</c:v>
                </c:pt>
                <c:pt idx="17">
                  <c:v>46347.822222222218</c:v>
                </c:pt>
                <c:pt idx="18">
                  <c:v>51035.577777777777</c:v>
                </c:pt>
                <c:pt idx="19">
                  <c:v>53766.355555555572</c:v>
                </c:pt>
                <c:pt idx="20">
                  <c:v>54902.2</c:v>
                </c:pt>
                <c:pt idx="21">
                  <c:v>59706.677777777775</c:v>
                </c:pt>
                <c:pt idx="22">
                  <c:v>59456.62222222222</c:v>
                </c:pt>
                <c:pt idx="23">
                  <c:v>59969.766666666663</c:v>
                </c:pt>
                <c:pt idx="24">
                  <c:v>59658.944444444431</c:v>
                </c:pt>
                <c:pt idx="25">
                  <c:v>64162.722222222241</c:v>
                </c:pt>
                <c:pt idx="26">
                  <c:v>63547.599999999991</c:v>
                </c:pt>
                <c:pt idx="27">
                  <c:v>66190.7</c:v>
                </c:pt>
                <c:pt idx="28">
                  <c:v>66687.311111111107</c:v>
                </c:pt>
                <c:pt idx="29">
                  <c:v>68715.511111111118</c:v>
                </c:pt>
                <c:pt idx="30">
                  <c:v>69455.822222222225</c:v>
                </c:pt>
                <c:pt idx="31">
                  <c:v>72576.666666666672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971872"/>
        <c:axId val="325979320"/>
      </c:lineChart>
      <c:catAx>
        <c:axId val="325971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 Thermal time (degree 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en-US"/>
          </a:p>
        </c:txPr>
        <c:crossAx val="325979320"/>
        <c:crosses val="autoZero"/>
        <c:auto val="1"/>
        <c:lblAlgn val="ctr"/>
        <c:lblOffset val="100"/>
        <c:noMultiLvlLbl val="0"/>
      </c:catAx>
      <c:valAx>
        <c:axId val="3259793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3D-leaf area (mm-2 sector-1)</a:t>
                </a:r>
              </a:p>
            </c:rich>
          </c:tx>
          <c:layout>
            <c:manualLayout>
              <c:xMode val="edge"/>
              <c:yMode val="edge"/>
              <c:x val="7.2390713299280082E-3"/>
              <c:y val="0.11442354130026951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spPr>
          <a:ln w="25400">
            <a:solidFill>
              <a:schemeClr val="tx1"/>
            </a:solidFill>
            <a:prstDash val="solid"/>
          </a:ln>
        </c:spPr>
        <c:crossAx val="3259718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5886820579466399"/>
          <c:y val="0.50529871853581987"/>
          <c:w val="0.33094067731824783"/>
          <c:h val="0.217062692907714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6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solidFill>
                  <a:srgbClr val="0000FF"/>
                </a:solidFill>
              </a:defRPr>
            </a:pPr>
            <a:r>
              <a:rPr lang="en-US">
                <a:solidFill>
                  <a:srgbClr val="0000FF"/>
                </a:solidFill>
              </a:rPr>
              <a:t>Plant height-Parental lines</a:t>
            </a:r>
          </a:p>
        </c:rich>
      </c:tx>
      <c:layout>
        <c:manualLayout>
          <c:xMode val="edge"/>
          <c:yMode val="edge"/>
          <c:x val="0.35333156173748403"/>
          <c:y val="9.289620609059894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4172320850624686E-2"/>
          <c:y val="8.1855254188735863E-2"/>
          <c:w val="0.85523459139922364"/>
          <c:h val="0.73308981604768242"/>
        </c:manualLayout>
      </c:layout>
      <c:lineChart>
        <c:grouping val="standard"/>
        <c:varyColors val="0"/>
        <c:ser>
          <c:idx val="0"/>
          <c:order val="0"/>
          <c:tx>
            <c:strRef>
              <c:f>Sheet5!$F$980</c:f>
              <c:strCache>
                <c:ptCount val="1"/>
                <c:pt idx="0">
                  <c:v> ICC 4958-High Vigor parent </c:v>
                </c:pt>
              </c:strCache>
            </c:strRef>
          </c:tx>
          <c:spPr>
            <a:ln w="28575">
              <a:solidFill>
                <a:srgbClr val="0000FF"/>
              </a:solidFill>
            </a:ln>
          </c:spPr>
          <c:marker>
            <c:symbol val="circle"/>
            <c:size val="9"/>
            <c:spPr>
              <a:solidFill>
                <a:srgbClr val="66FF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G$982:$AR$982</c:f>
                <c:numCache>
                  <c:formatCode>General</c:formatCode>
                  <c:ptCount val="38"/>
                  <c:pt idx="0">
                    <c:v>1.1881042322400219</c:v>
                  </c:pt>
                  <c:pt idx="1">
                    <c:v>2.4640021645012111</c:v>
                  </c:pt>
                  <c:pt idx="2">
                    <c:v>2.6397113689021268</c:v>
                  </c:pt>
                  <c:pt idx="3">
                    <c:v>1.6900664023772685</c:v>
                  </c:pt>
                  <c:pt idx="4">
                    <c:v>1.8382159225123089</c:v>
                  </c:pt>
                  <c:pt idx="5">
                    <c:v>1.6715210970184551</c:v>
                  </c:pt>
                  <c:pt idx="6">
                    <c:v>1.8216611771798954</c:v>
                  </c:pt>
                  <c:pt idx="7">
                    <c:v>1.94399831389959</c:v>
                  </c:pt>
                  <c:pt idx="8">
                    <c:v>1.5838590355345523</c:v>
                  </c:pt>
                  <c:pt idx="9">
                    <c:v>2.1172997740833344</c:v>
                  </c:pt>
                  <c:pt idx="10">
                    <c:v>2.3897112796319147</c:v>
                  </c:pt>
                  <c:pt idx="11">
                    <c:v>0.70315677088715101</c:v>
                  </c:pt>
                  <c:pt idx="12">
                    <c:v>0.99037927639420631</c:v>
                  </c:pt>
                  <c:pt idx="13">
                    <c:v>1.1181962161346179</c:v>
                  </c:pt>
                  <c:pt idx="14">
                    <c:v>2.4019653122206219</c:v>
                  </c:pt>
                  <c:pt idx="15">
                    <c:v>2.3955718408022011</c:v>
                  </c:pt>
                  <c:pt idx="16">
                    <c:v>2.4312087757144822</c:v>
                  </c:pt>
                  <c:pt idx="17">
                    <c:v>2.4172182416525363</c:v>
                  </c:pt>
                  <c:pt idx="18">
                    <c:v>2.39580014469766</c:v>
                  </c:pt>
                  <c:pt idx="19">
                    <c:v>2.2260868756132988</c:v>
                  </c:pt>
                  <c:pt idx="20">
                    <c:v>2.3496814204861423</c:v>
                  </c:pt>
                  <c:pt idx="21">
                    <c:v>2.4095915974842437</c:v>
                  </c:pt>
                  <c:pt idx="22">
                    <c:v>2.5671494134761832</c:v>
                  </c:pt>
                  <c:pt idx="23">
                    <c:v>2.3107652652554558</c:v>
                  </c:pt>
                  <c:pt idx="24">
                    <c:v>2.3950917402981551</c:v>
                  </c:pt>
                  <c:pt idx="25">
                    <c:v>2.2999489124761006</c:v>
                  </c:pt>
                  <c:pt idx="26">
                    <c:v>2.7123074432421301</c:v>
                  </c:pt>
                  <c:pt idx="27">
                    <c:v>2.037905242590484</c:v>
                  </c:pt>
                  <c:pt idx="28">
                    <c:v>2.4556718926689798</c:v>
                  </c:pt>
                  <c:pt idx="29">
                    <c:v>2.327774927073301</c:v>
                  </c:pt>
                  <c:pt idx="30">
                    <c:v>1.8554378039817028</c:v>
                  </c:pt>
                  <c:pt idx="31">
                    <c:v>2.4314467572483132</c:v>
                  </c:pt>
                  <c:pt idx="32">
                    <c:v>2.1445850414474128</c:v>
                  </c:pt>
                  <c:pt idx="33">
                    <c:v>2.8449058762012567</c:v>
                  </c:pt>
                  <c:pt idx="34">
                    <c:v>4.1754502085936123</c:v>
                  </c:pt>
                  <c:pt idx="35">
                    <c:v>4.2149100425355073</c:v>
                  </c:pt>
                  <c:pt idx="36">
                    <c:v>4.4502137901204</c:v>
                  </c:pt>
                  <c:pt idx="37">
                    <c:v>4.6842208530341534</c:v>
                  </c:pt>
                </c:numCache>
              </c:numRef>
            </c:plus>
            <c:minus>
              <c:numRef>
                <c:f>Sheet5!$G$982:$AR$982</c:f>
                <c:numCache>
                  <c:formatCode>General</c:formatCode>
                  <c:ptCount val="38"/>
                  <c:pt idx="0">
                    <c:v>1.1881042322400219</c:v>
                  </c:pt>
                  <c:pt idx="1">
                    <c:v>2.4640021645012111</c:v>
                  </c:pt>
                  <c:pt idx="2">
                    <c:v>2.6397113689021268</c:v>
                  </c:pt>
                  <c:pt idx="3">
                    <c:v>1.6900664023772685</c:v>
                  </c:pt>
                  <c:pt idx="4">
                    <c:v>1.8382159225123089</c:v>
                  </c:pt>
                  <c:pt idx="5">
                    <c:v>1.6715210970184551</c:v>
                  </c:pt>
                  <c:pt idx="6">
                    <c:v>1.8216611771798954</c:v>
                  </c:pt>
                  <c:pt idx="7">
                    <c:v>1.94399831389959</c:v>
                  </c:pt>
                  <c:pt idx="8">
                    <c:v>1.5838590355345523</c:v>
                  </c:pt>
                  <c:pt idx="9">
                    <c:v>2.1172997740833344</c:v>
                  </c:pt>
                  <c:pt idx="10">
                    <c:v>2.3897112796319147</c:v>
                  </c:pt>
                  <c:pt idx="11">
                    <c:v>0.70315677088715101</c:v>
                  </c:pt>
                  <c:pt idx="12">
                    <c:v>0.99037927639420631</c:v>
                  </c:pt>
                  <c:pt idx="13">
                    <c:v>1.1181962161346179</c:v>
                  </c:pt>
                  <c:pt idx="14">
                    <c:v>2.4019653122206219</c:v>
                  </c:pt>
                  <c:pt idx="15">
                    <c:v>2.3955718408022011</c:v>
                  </c:pt>
                  <c:pt idx="16">
                    <c:v>2.4312087757144822</c:v>
                  </c:pt>
                  <c:pt idx="17">
                    <c:v>2.4172182416525363</c:v>
                  </c:pt>
                  <c:pt idx="18">
                    <c:v>2.39580014469766</c:v>
                  </c:pt>
                  <c:pt idx="19">
                    <c:v>2.2260868756132988</c:v>
                  </c:pt>
                  <c:pt idx="20">
                    <c:v>2.3496814204861423</c:v>
                  </c:pt>
                  <c:pt idx="21">
                    <c:v>2.4095915974842437</c:v>
                  </c:pt>
                  <c:pt idx="22">
                    <c:v>2.5671494134761832</c:v>
                  </c:pt>
                  <c:pt idx="23">
                    <c:v>2.3107652652554558</c:v>
                  </c:pt>
                  <c:pt idx="24">
                    <c:v>2.3950917402981551</c:v>
                  </c:pt>
                  <c:pt idx="25">
                    <c:v>2.2999489124761006</c:v>
                  </c:pt>
                  <c:pt idx="26">
                    <c:v>2.7123074432421301</c:v>
                  </c:pt>
                  <c:pt idx="27">
                    <c:v>2.037905242590484</c:v>
                  </c:pt>
                  <c:pt idx="28">
                    <c:v>2.4556718926689798</c:v>
                  </c:pt>
                  <c:pt idx="29">
                    <c:v>2.327774927073301</c:v>
                  </c:pt>
                  <c:pt idx="30">
                    <c:v>1.8554378039817028</c:v>
                  </c:pt>
                  <c:pt idx="31">
                    <c:v>2.4314467572483132</c:v>
                  </c:pt>
                  <c:pt idx="32">
                    <c:v>2.1445850414474128</c:v>
                  </c:pt>
                  <c:pt idx="33">
                    <c:v>2.8449058762012567</c:v>
                  </c:pt>
                  <c:pt idx="34">
                    <c:v>4.1754502085936123</c:v>
                  </c:pt>
                  <c:pt idx="35">
                    <c:v>4.2149100425355073</c:v>
                  </c:pt>
                  <c:pt idx="36">
                    <c:v>4.4502137901204</c:v>
                  </c:pt>
                  <c:pt idx="37">
                    <c:v>4.6842208530341534</c:v>
                  </c:pt>
                </c:numCache>
              </c:numRef>
            </c:minus>
          </c:errBars>
          <c:cat>
            <c:numRef>
              <c:f>Sheet5!$G$985:$AR$985</c:f>
              <c:numCache>
                <c:formatCode>General</c:formatCode>
                <c:ptCount val="38"/>
                <c:pt idx="0">
                  <c:v>114</c:v>
                </c:pt>
                <c:pt idx="1">
                  <c:v>133</c:v>
                </c:pt>
                <c:pt idx="2">
                  <c:v>152</c:v>
                </c:pt>
                <c:pt idx="3">
                  <c:v>171</c:v>
                </c:pt>
                <c:pt idx="4">
                  <c:v>190</c:v>
                </c:pt>
                <c:pt idx="5">
                  <c:v>209</c:v>
                </c:pt>
                <c:pt idx="6">
                  <c:v>228</c:v>
                </c:pt>
                <c:pt idx="7">
                  <c:v>247</c:v>
                </c:pt>
                <c:pt idx="8">
                  <c:v>266</c:v>
                </c:pt>
                <c:pt idx="9">
                  <c:v>285</c:v>
                </c:pt>
                <c:pt idx="10">
                  <c:v>304</c:v>
                </c:pt>
                <c:pt idx="11">
                  <c:v>323</c:v>
                </c:pt>
                <c:pt idx="12">
                  <c:v>342</c:v>
                </c:pt>
                <c:pt idx="13">
                  <c:v>361</c:v>
                </c:pt>
                <c:pt idx="14">
                  <c:v>380</c:v>
                </c:pt>
                <c:pt idx="15">
                  <c:v>399</c:v>
                </c:pt>
                <c:pt idx="16">
                  <c:v>418</c:v>
                </c:pt>
                <c:pt idx="17">
                  <c:v>437</c:v>
                </c:pt>
                <c:pt idx="18">
                  <c:v>456</c:v>
                </c:pt>
                <c:pt idx="19">
                  <c:v>475</c:v>
                </c:pt>
                <c:pt idx="20">
                  <c:v>494</c:v>
                </c:pt>
                <c:pt idx="21">
                  <c:v>513</c:v>
                </c:pt>
                <c:pt idx="22">
                  <c:v>532</c:v>
                </c:pt>
                <c:pt idx="23">
                  <c:v>551</c:v>
                </c:pt>
                <c:pt idx="24">
                  <c:v>570</c:v>
                </c:pt>
                <c:pt idx="25">
                  <c:v>589</c:v>
                </c:pt>
                <c:pt idx="26">
                  <c:v>608</c:v>
                </c:pt>
                <c:pt idx="27">
                  <c:v>627</c:v>
                </c:pt>
                <c:pt idx="28">
                  <c:v>646</c:v>
                </c:pt>
                <c:pt idx="29">
                  <c:v>665</c:v>
                </c:pt>
                <c:pt idx="30">
                  <c:v>680</c:v>
                </c:pt>
                <c:pt idx="31" formatCode="0">
                  <c:v>696.05</c:v>
                </c:pt>
                <c:pt idx="32" formatCode="0">
                  <c:v>712.55</c:v>
                </c:pt>
                <c:pt idx="33" formatCode="0">
                  <c:v>730.34999999999991</c:v>
                </c:pt>
                <c:pt idx="34" formatCode="0">
                  <c:v>749.05</c:v>
                </c:pt>
                <c:pt idx="35" formatCode="0">
                  <c:v>768.05</c:v>
                </c:pt>
                <c:pt idx="36" formatCode="0">
                  <c:v>787.05</c:v>
                </c:pt>
                <c:pt idx="37" formatCode="0">
                  <c:v>806.05</c:v>
                </c:pt>
              </c:numCache>
            </c:numRef>
          </c:cat>
          <c:val>
            <c:numRef>
              <c:f>Sheet5!$G$980:$AR$980</c:f>
              <c:numCache>
                <c:formatCode>0.00</c:formatCode>
                <c:ptCount val="38"/>
                <c:pt idx="0">
                  <c:v>17.04</c:v>
                </c:pt>
                <c:pt idx="1">
                  <c:v>27.27</c:v>
                </c:pt>
                <c:pt idx="2">
                  <c:v>40.871666666666663</c:v>
                </c:pt>
                <c:pt idx="3">
                  <c:v>48.416666666666664</c:v>
                </c:pt>
                <c:pt idx="4">
                  <c:v>56.236666666666657</c:v>
                </c:pt>
                <c:pt idx="5">
                  <c:v>63.861666666666657</c:v>
                </c:pt>
                <c:pt idx="6">
                  <c:v>73.491666666666674</c:v>
                </c:pt>
                <c:pt idx="7">
                  <c:v>80.018333333333331</c:v>
                </c:pt>
                <c:pt idx="8">
                  <c:v>86.138333333333335</c:v>
                </c:pt>
                <c:pt idx="9">
                  <c:v>88.745000000000005</c:v>
                </c:pt>
                <c:pt idx="10">
                  <c:v>90.840000000000018</c:v>
                </c:pt>
                <c:pt idx="11">
                  <c:v>94.431666666666672</c:v>
                </c:pt>
                <c:pt idx="12">
                  <c:v>98.353333333333339</c:v>
                </c:pt>
                <c:pt idx="13">
                  <c:v>100.64166666666667</c:v>
                </c:pt>
                <c:pt idx="14">
                  <c:v>100.95916666666666</c:v>
                </c:pt>
                <c:pt idx="15">
                  <c:v>102.19333333333333</c:v>
                </c:pt>
                <c:pt idx="16">
                  <c:v>103.77833333333335</c:v>
                </c:pt>
                <c:pt idx="17">
                  <c:v>106.38916666666665</c:v>
                </c:pt>
                <c:pt idx="18">
                  <c:v>109.40499999999999</c:v>
                </c:pt>
                <c:pt idx="19">
                  <c:v>113.39166666666665</c:v>
                </c:pt>
                <c:pt idx="20">
                  <c:v>115.13833333333332</c:v>
                </c:pt>
                <c:pt idx="21">
                  <c:v>115.955</c:v>
                </c:pt>
                <c:pt idx="22">
                  <c:v>118.52166666666666</c:v>
                </c:pt>
                <c:pt idx="23">
                  <c:v>120.12166666666667</c:v>
                </c:pt>
                <c:pt idx="24">
                  <c:v>122.34333333333335</c:v>
                </c:pt>
                <c:pt idx="25">
                  <c:v>125.03500000000001</c:v>
                </c:pt>
                <c:pt idx="26">
                  <c:v>127.96499999999999</c:v>
                </c:pt>
                <c:pt idx="27">
                  <c:v>129.86333333333334</c:v>
                </c:pt>
                <c:pt idx="28">
                  <c:v>131.61333333333332</c:v>
                </c:pt>
                <c:pt idx="29">
                  <c:v>133.91166666666666</c:v>
                </c:pt>
                <c:pt idx="30">
                  <c:v>132.95833333333334</c:v>
                </c:pt>
                <c:pt idx="31">
                  <c:v>135.66</c:v>
                </c:pt>
                <c:pt idx="32">
                  <c:v>137.845</c:v>
                </c:pt>
                <c:pt idx="33">
                  <c:v>141.20166666666665</c:v>
                </c:pt>
                <c:pt idx="34">
                  <c:v>143.71333333333334</c:v>
                </c:pt>
                <c:pt idx="35">
                  <c:v>145.94999999999999</c:v>
                </c:pt>
                <c:pt idx="36">
                  <c:v>147.76833333333335</c:v>
                </c:pt>
                <c:pt idx="37">
                  <c:v>151.3249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5!$F$981</c:f>
              <c:strCache>
                <c:ptCount val="1"/>
                <c:pt idx="0">
                  <c:v> ICC 1882-Low Vigor parent </c:v>
                </c:pt>
              </c:strCache>
            </c:strRef>
          </c:tx>
          <c:spPr>
            <a:ln w="28575">
              <a:solidFill>
                <a:srgbClr val="FF0000"/>
              </a:solidFill>
            </a:ln>
          </c:spPr>
          <c:marker>
            <c:symbol val="circle"/>
            <c:size val="9"/>
            <c:spPr>
              <a:solidFill>
                <a:srgbClr val="FFFF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G$983:$AR$983</c:f>
                <c:numCache>
                  <c:formatCode>General</c:formatCode>
                  <c:ptCount val="38"/>
                  <c:pt idx="0">
                    <c:v>0.38583243340427809</c:v>
                  </c:pt>
                  <c:pt idx="1">
                    <c:v>1.1107533104459653</c:v>
                  </c:pt>
                  <c:pt idx="2">
                    <c:v>1.7845978772074471</c:v>
                  </c:pt>
                  <c:pt idx="3">
                    <c:v>4.4067077185430286</c:v>
                  </c:pt>
                  <c:pt idx="4">
                    <c:v>2.2334315898783803</c:v>
                  </c:pt>
                  <c:pt idx="5">
                    <c:v>3.1204949749821655</c:v>
                  </c:pt>
                  <c:pt idx="6">
                    <c:v>1.7430050678832421</c:v>
                  </c:pt>
                  <c:pt idx="7">
                    <c:v>1.7626731593425562</c:v>
                  </c:pt>
                  <c:pt idx="8">
                    <c:v>1.6771122668311607</c:v>
                  </c:pt>
                  <c:pt idx="9">
                    <c:v>2.061659256251839</c:v>
                  </c:pt>
                  <c:pt idx="10">
                    <c:v>1.8920902609430552</c:v>
                  </c:pt>
                  <c:pt idx="11">
                    <c:v>0.62360956446232352</c:v>
                  </c:pt>
                  <c:pt idx="12">
                    <c:v>1.5290901434077282</c:v>
                  </c:pt>
                  <c:pt idx="13">
                    <c:v>0.70710678118654757</c:v>
                  </c:pt>
                  <c:pt idx="14">
                    <c:v>0.24257587587300553</c:v>
                  </c:pt>
                  <c:pt idx="15">
                    <c:v>1.6126599834503943</c:v>
                  </c:pt>
                  <c:pt idx="16">
                    <c:v>0.55713553108736502</c:v>
                  </c:pt>
                  <c:pt idx="17">
                    <c:v>1.7086885809493391</c:v>
                  </c:pt>
                  <c:pt idx="18">
                    <c:v>1.4931752148432627</c:v>
                  </c:pt>
                  <c:pt idx="19">
                    <c:v>2.2645909613486985</c:v>
                  </c:pt>
                  <c:pt idx="20">
                    <c:v>2.3866817969725238</c:v>
                  </c:pt>
                  <c:pt idx="21">
                    <c:v>2.0174337384134553</c:v>
                  </c:pt>
                  <c:pt idx="22">
                    <c:v>2.0429812094638118</c:v>
                  </c:pt>
                  <c:pt idx="23">
                    <c:v>1.9612085276402622</c:v>
                  </c:pt>
                  <c:pt idx="24">
                    <c:v>2.1207349355038851</c:v>
                  </c:pt>
                  <c:pt idx="25">
                    <c:v>1.9719970137457672</c:v>
                  </c:pt>
                  <c:pt idx="26">
                    <c:v>1.8479282694111503</c:v>
                  </c:pt>
                  <c:pt idx="27">
                    <c:v>1.8058069910399861</c:v>
                  </c:pt>
                  <c:pt idx="28">
                    <c:v>2.177220450227511</c:v>
                  </c:pt>
                  <c:pt idx="29">
                    <c:v>2.9040001147842029</c:v>
                  </c:pt>
                  <c:pt idx="30">
                    <c:v>2.8994223562633996</c:v>
                  </c:pt>
                  <c:pt idx="31">
                    <c:v>2.8119595777085173</c:v>
                  </c:pt>
                  <c:pt idx="32">
                    <c:v>2.6758768033425357</c:v>
                  </c:pt>
                  <c:pt idx="33">
                    <c:v>2.2420464362323593</c:v>
                  </c:pt>
                  <c:pt idx="34">
                    <c:v>2.5142825351711502</c:v>
                  </c:pt>
                  <c:pt idx="35">
                    <c:v>2.7459454959388143</c:v>
                  </c:pt>
                  <c:pt idx="36">
                    <c:v>3.0321893447181409</c:v>
                  </c:pt>
                  <c:pt idx="37">
                    <c:v>3.6062938809192389</c:v>
                  </c:pt>
                </c:numCache>
              </c:numRef>
            </c:plus>
            <c:minus>
              <c:numRef>
                <c:f>Sheet5!$G$983:$AR$983</c:f>
                <c:numCache>
                  <c:formatCode>General</c:formatCode>
                  <c:ptCount val="38"/>
                  <c:pt idx="0">
                    <c:v>0.38583243340427809</c:v>
                  </c:pt>
                  <c:pt idx="1">
                    <c:v>1.1107533104459653</c:v>
                  </c:pt>
                  <c:pt idx="2">
                    <c:v>1.7845978772074471</c:v>
                  </c:pt>
                  <c:pt idx="3">
                    <c:v>4.4067077185430286</c:v>
                  </c:pt>
                  <c:pt idx="4">
                    <c:v>2.2334315898783803</c:v>
                  </c:pt>
                  <c:pt idx="5">
                    <c:v>3.1204949749821655</c:v>
                  </c:pt>
                  <c:pt idx="6">
                    <c:v>1.7430050678832421</c:v>
                  </c:pt>
                  <c:pt idx="7">
                    <c:v>1.7626731593425562</c:v>
                  </c:pt>
                  <c:pt idx="8">
                    <c:v>1.6771122668311607</c:v>
                  </c:pt>
                  <c:pt idx="9">
                    <c:v>2.061659256251839</c:v>
                  </c:pt>
                  <c:pt idx="10">
                    <c:v>1.8920902609430552</c:v>
                  </c:pt>
                  <c:pt idx="11">
                    <c:v>0.62360956446232352</c:v>
                  </c:pt>
                  <c:pt idx="12">
                    <c:v>1.5290901434077282</c:v>
                  </c:pt>
                  <c:pt idx="13">
                    <c:v>0.70710678118654757</c:v>
                  </c:pt>
                  <c:pt idx="14">
                    <c:v>0.24257587587300553</c:v>
                  </c:pt>
                  <c:pt idx="15">
                    <c:v>1.6126599834503943</c:v>
                  </c:pt>
                  <c:pt idx="16">
                    <c:v>0.55713553108736502</c:v>
                  </c:pt>
                  <c:pt idx="17">
                    <c:v>1.7086885809493391</c:v>
                  </c:pt>
                  <c:pt idx="18">
                    <c:v>1.4931752148432627</c:v>
                  </c:pt>
                  <c:pt idx="19">
                    <c:v>2.2645909613486985</c:v>
                  </c:pt>
                  <c:pt idx="20">
                    <c:v>2.3866817969725238</c:v>
                  </c:pt>
                  <c:pt idx="21">
                    <c:v>2.0174337384134553</c:v>
                  </c:pt>
                  <c:pt idx="22">
                    <c:v>2.0429812094638118</c:v>
                  </c:pt>
                  <c:pt idx="23">
                    <c:v>1.9612085276402622</c:v>
                  </c:pt>
                  <c:pt idx="24">
                    <c:v>2.1207349355038851</c:v>
                  </c:pt>
                  <c:pt idx="25">
                    <c:v>1.9719970137457672</c:v>
                  </c:pt>
                  <c:pt idx="26">
                    <c:v>1.8479282694111503</c:v>
                  </c:pt>
                  <c:pt idx="27">
                    <c:v>1.8058069910399861</c:v>
                  </c:pt>
                  <c:pt idx="28">
                    <c:v>2.177220450227511</c:v>
                  </c:pt>
                  <c:pt idx="29">
                    <c:v>2.9040001147842029</c:v>
                  </c:pt>
                  <c:pt idx="30">
                    <c:v>2.8994223562633996</c:v>
                  </c:pt>
                  <c:pt idx="31">
                    <c:v>2.8119595777085173</c:v>
                  </c:pt>
                  <c:pt idx="32">
                    <c:v>2.6758768033425357</c:v>
                  </c:pt>
                  <c:pt idx="33">
                    <c:v>2.2420464362323593</c:v>
                  </c:pt>
                  <c:pt idx="34">
                    <c:v>2.5142825351711502</c:v>
                  </c:pt>
                  <c:pt idx="35">
                    <c:v>2.7459454959388143</c:v>
                  </c:pt>
                  <c:pt idx="36">
                    <c:v>3.0321893447181409</c:v>
                  </c:pt>
                  <c:pt idx="37">
                    <c:v>3.6062938809192389</c:v>
                  </c:pt>
                </c:numCache>
              </c:numRef>
            </c:minus>
          </c:errBars>
          <c:cat>
            <c:numRef>
              <c:f>Sheet5!$G$985:$AR$985</c:f>
              <c:numCache>
                <c:formatCode>General</c:formatCode>
                <c:ptCount val="38"/>
                <c:pt idx="0">
                  <c:v>114</c:v>
                </c:pt>
                <c:pt idx="1">
                  <c:v>133</c:v>
                </c:pt>
                <c:pt idx="2">
                  <c:v>152</c:v>
                </c:pt>
                <c:pt idx="3">
                  <c:v>171</c:v>
                </c:pt>
                <c:pt idx="4">
                  <c:v>190</c:v>
                </c:pt>
                <c:pt idx="5">
                  <c:v>209</c:v>
                </c:pt>
                <c:pt idx="6">
                  <c:v>228</c:v>
                </c:pt>
                <c:pt idx="7">
                  <c:v>247</c:v>
                </c:pt>
                <c:pt idx="8">
                  <c:v>266</c:v>
                </c:pt>
                <c:pt idx="9">
                  <c:v>285</c:v>
                </c:pt>
                <c:pt idx="10">
                  <c:v>304</c:v>
                </c:pt>
                <c:pt idx="11">
                  <c:v>323</c:v>
                </c:pt>
                <c:pt idx="12">
                  <c:v>342</c:v>
                </c:pt>
                <c:pt idx="13">
                  <c:v>361</c:v>
                </c:pt>
                <c:pt idx="14">
                  <c:v>380</c:v>
                </c:pt>
                <c:pt idx="15">
                  <c:v>399</c:v>
                </c:pt>
                <c:pt idx="16">
                  <c:v>418</c:v>
                </c:pt>
                <c:pt idx="17">
                  <c:v>437</c:v>
                </c:pt>
                <c:pt idx="18">
                  <c:v>456</c:v>
                </c:pt>
                <c:pt idx="19">
                  <c:v>475</c:v>
                </c:pt>
                <c:pt idx="20">
                  <c:v>494</c:v>
                </c:pt>
                <c:pt idx="21">
                  <c:v>513</c:v>
                </c:pt>
                <c:pt idx="22">
                  <c:v>532</c:v>
                </c:pt>
                <c:pt idx="23">
                  <c:v>551</c:v>
                </c:pt>
                <c:pt idx="24">
                  <c:v>570</c:v>
                </c:pt>
                <c:pt idx="25">
                  <c:v>589</c:v>
                </c:pt>
                <c:pt idx="26">
                  <c:v>608</c:v>
                </c:pt>
                <c:pt idx="27">
                  <c:v>627</c:v>
                </c:pt>
                <c:pt idx="28">
                  <c:v>646</c:v>
                </c:pt>
                <c:pt idx="29">
                  <c:v>665</c:v>
                </c:pt>
                <c:pt idx="30">
                  <c:v>680</c:v>
                </c:pt>
                <c:pt idx="31" formatCode="0">
                  <c:v>696.05</c:v>
                </c:pt>
                <c:pt idx="32" formatCode="0">
                  <c:v>712.55</c:v>
                </c:pt>
                <c:pt idx="33" formatCode="0">
                  <c:v>730.34999999999991</c:v>
                </c:pt>
                <c:pt idx="34" formatCode="0">
                  <c:v>749.05</c:v>
                </c:pt>
                <c:pt idx="35" formatCode="0">
                  <c:v>768.05</c:v>
                </c:pt>
                <c:pt idx="36" formatCode="0">
                  <c:v>787.05</c:v>
                </c:pt>
                <c:pt idx="37" formatCode="0">
                  <c:v>806.05</c:v>
                </c:pt>
              </c:numCache>
            </c:numRef>
          </c:cat>
          <c:val>
            <c:numRef>
              <c:f>Sheet5!$G$981:$AR$981</c:f>
              <c:numCache>
                <c:formatCode>0.00</c:formatCode>
                <c:ptCount val="38"/>
                <c:pt idx="0">
                  <c:v>14.120000000000001</c:v>
                </c:pt>
                <c:pt idx="1">
                  <c:v>15.922499999999999</c:v>
                </c:pt>
                <c:pt idx="2">
                  <c:v>20.647500000000001</c:v>
                </c:pt>
                <c:pt idx="3">
                  <c:v>27.3675</c:v>
                </c:pt>
                <c:pt idx="4">
                  <c:v>29.1</c:v>
                </c:pt>
                <c:pt idx="5">
                  <c:v>32.153333333333336</c:v>
                </c:pt>
                <c:pt idx="6">
                  <c:v>39.32</c:v>
                </c:pt>
                <c:pt idx="7">
                  <c:v>42.870000000000005</c:v>
                </c:pt>
                <c:pt idx="8">
                  <c:v>44.843333333333327</c:v>
                </c:pt>
                <c:pt idx="9">
                  <c:v>46.083333333333336</c:v>
                </c:pt>
                <c:pt idx="10">
                  <c:v>47.196666666666665</c:v>
                </c:pt>
                <c:pt idx="11">
                  <c:v>49.666666666666664</c:v>
                </c:pt>
                <c:pt idx="12">
                  <c:v>50.73</c:v>
                </c:pt>
                <c:pt idx="13">
                  <c:v>51</c:v>
                </c:pt>
                <c:pt idx="14">
                  <c:v>53.051666666666662</c:v>
                </c:pt>
                <c:pt idx="15">
                  <c:v>53.996666666666663</c:v>
                </c:pt>
                <c:pt idx="16">
                  <c:v>55.599999999999994</c:v>
                </c:pt>
                <c:pt idx="17">
                  <c:v>55.35</c:v>
                </c:pt>
                <c:pt idx="18">
                  <c:v>55.783333333333331</c:v>
                </c:pt>
                <c:pt idx="19">
                  <c:v>56.706666666666663</c:v>
                </c:pt>
                <c:pt idx="20">
                  <c:v>57.150000000000006</c:v>
                </c:pt>
                <c:pt idx="21">
                  <c:v>57.833333333333336</c:v>
                </c:pt>
                <c:pt idx="22">
                  <c:v>58.593333333333334</c:v>
                </c:pt>
                <c:pt idx="23">
                  <c:v>59.356666666666669</c:v>
                </c:pt>
                <c:pt idx="24">
                  <c:v>60.070000000000007</c:v>
                </c:pt>
                <c:pt idx="25">
                  <c:v>62.266666666666666</c:v>
                </c:pt>
                <c:pt idx="26">
                  <c:v>63.553333333333342</c:v>
                </c:pt>
                <c:pt idx="27">
                  <c:v>65.413333333333327</c:v>
                </c:pt>
                <c:pt idx="28">
                  <c:v>66.963333333333338</c:v>
                </c:pt>
                <c:pt idx="29">
                  <c:v>69.259999999999991</c:v>
                </c:pt>
                <c:pt idx="30">
                  <c:v>68.89</c:v>
                </c:pt>
                <c:pt idx="31">
                  <c:v>70.180000000000007</c:v>
                </c:pt>
                <c:pt idx="32">
                  <c:v>71.589999999999989</c:v>
                </c:pt>
                <c:pt idx="33">
                  <c:v>74.146666666666675</c:v>
                </c:pt>
                <c:pt idx="34">
                  <c:v>75.11</c:v>
                </c:pt>
                <c:pt idx="35">
                  <c:v>79.28</c:v>
                </c:pt>
                <c:pt idx="36">
                  <c:v>81.663333333333341</c:v>
                </c:pt>
                <c:pt idx="37">
                  <c:v>85.79333333333333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982456"/>
        <c:axId val="325978928"/>
      </c:lineChart>
      <c:catAx>
        <c:axId val="3259824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hermal time (degree days)</a:t>
                </a:r>
              </a:p>
            </c:rich>
          </c:tx>
          <c:layout>
            <c:manualLayout>
              <c:xMode val="edge"/>
              <c:yMode val="edge"/>
              <c:x val="0.34003444881889761"/>
              <c:y val="0.916203925596256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2225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en-US"/>
          </a:p>
        </c:txPr>
        <c:crossAx val="325978928"/>
        <c:crosses val="autoZero"/>
        <c:auto val="1"/>
        <c:lblAlgn val="ctr"/>
        <c:lblOffset val="100"/>
        <c:noMultiLvlLbl val="0"/>
      </c:catAx>
      <c:valAx>
        <c:axId val="325978928"/>
        <c:scaling>
          <c:orientation val="minMax"/>
          <c:max val="18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lant height (cm sector-1)</a:t>
                </a:r>
              </a:p>
            </c:rich>
          </c:tx>
          <c:layout>
            <c:manualLayout>
              <c:xMode val="edge"/>
              <c:yMode val="edge"/>
              <c:x val="1.0159842710158282E-2"/>
              <c:y val="0.1879630380991022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22225">
            <a:solidFill>
              <a:schemeClr val="tx1"/>
            </a:solidFill>
          </a:ln>
        </c:spPr>
        <c:crossAx val="3259824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6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6CD8FC-DB15-454F-9149-4E77CD96A24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4425" y="1143000"/>
            <a:ext cx="4629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7E55D7-B42D-43D0-8CAD-D3A227A91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93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496484"/>
            <a:ext cx="116586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4802717"/>
            <a:ext cx="10287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228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101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486834"/>
            <a:ext cx="2957513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486834"/>
            <a:ext cx="8701088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658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701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279653"/>
            <a:ext cx="1183005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6119286"/>
            <a:ext cx="1183005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746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2434167"/>
            <a:ext cx="582930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2434167"/>
            <a:ext cx="582930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46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86836"/>
            <a:ext cx="1183005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241551"/>
            <a:ext cx="5802510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3340100"/>
            <a:ext cx="5802510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241551"/>
            <a:ext cx="58310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3340100"/>
            <a:ext cx="5831087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83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803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751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609600"/>
            <a:ext cx="442376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316569"/>
            <a:ext cx="6943725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743200"/>
            <a:ext cx="442376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664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609600"/>
            <a:ext cx="442376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316569"/>
            <a:ext cx="6943725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743200"/>
            <a:ext cx="442376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36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486836"/>
            <a:ext cx="1183005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2434167"/>
            <a:ext cx="1183005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8475136"/>
            <a:ext cx="30861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EA2FA-AADC-4777-8EAE-222C73E07D24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8475136"/>
            <a:ext cx="46291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8475136"/>
            <a:ext cx="30861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63746-E340-43E3-9A53-D6EE7DD1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820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1885950" y="714375"/>
          <a:ext cx="10029826" cy="762952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14913"/>
                <a:gridCol w="5014913"/>
              </a:tblGrid>
              <a:tr h="3814763">
                <a:tc>
                  <a:txBody>
                    <a:bodyPr/>
                    <a:lstStyle/>
                    <a:p>
                      <a:endParaRPr lang="en-US" sz="2000" dirty="0"/>
                    </a:p>
                  </a:txBody>
                  <a:tcPr marL="102870" marR="102870" marT="51435" marB="51435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dirty="0"/>
                    </a:p>
                  </a:txBody>
                  <a:tcPr marL="102870" marR="102870" marT="51435" marB="51435">
                    <a:noFill/>
                  </a:tcPr>
                </a:tc>
              </a:tr>
              <a:tr h="3814763">
                <a:tc>
                  <a:txBody>
                    <a:bodyPr/>
                    <a:lstStyle/>
                    <a:p>
                      <a:endParaRPr lang="en-US" sz="2000" dirty="0"/>
                    </a:p>
                  </a:txBody>
                  <a:tcPr marL="102870" marR="102870" marT="51435" marB="51435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dirty="0"/>
                    </a:p>
                  </a:txBody>
                  <a:tcPr marL="102870" marR="102870" marT="51435" marB="51435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8871243"/>
              </p:ext>
            </p:extLst>
          </p:nvPr>
        </p:nvGraphicFramePr>
        <p:xfrm>
          <a:off x="143435" y="197223"/>
          <a:ext cx="13572565" cy="49485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2365434"/>
              </p:ext>
            </p:extLst>
          </p:nvPr>
        </p:nvGraphicFramePr>
        <p:xfrm>
          <a:off x="1" y="4733424"/>
          <a:ext cx="13554634" cy="4374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90500" y="0"/>
            <a:ext cx="342900" cy="4662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30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0500" y="4500284"/>
            <a:ext cx="342900" cy="4662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30" b="1" dirty="0"/>
              <a:t>B</a:t>
            </a:r>
            <a:endParaRPr lang="en-US" sz="243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/>
          <a:srcRect l="69462" t="49638" r="5711" b="27573"/>
          <a:stretch/>
        </p:blipFill>
        <p:spPr>
          <a:xfrm>
            <a:off x="9215717" y="7135906"/>
            <a:ext cx="3693459" cy="1129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569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35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vasakthi</dc:creator>
  <cp:lastModifiedBy>Sivasakthi</cp:lastModifiedBy>
  <cp:revision>2</cp:revision>
  <dcterms:created xsi:type="dcterms:W3CDTF">2017-05-16T19:28:24Z</dcterms:created>
  <dcterms:modified xsi:type="dcterms:W3CDTF">2017-05-16T19:39:45Z</dcterms:modified>
</cp:coreProperties>
</file>